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9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09"/>
    <p:restoredTop sz="94660"/>
  </p:normalViewPr>
  <p:slideViewPr>
    <p:cSldViewPr snapToGrid="0">
      <p:cViewPr>
        <p:scale>
          <a:sx n="120" d="100"/>
          <a:sy n="120" d="100"/>
        </p:scale>
        <p:origin x="-4992" y="-15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2" d="100"/>
          <a:sy n="52" d="100"/>
        </p:scale>
        <p:origin x="2958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868358276203099"/>
          <c:y val="5.7570523891767401E-2"/>
          <c:w val="0.68241574804160898"/>
          <c:h val="0.854034356456737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O$31</c:f>
              <c:strCache>
                <c:ptCount val="1"/>
                <c:pt idx="0">
                  <c:v>Spathe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32:$U$36</c:f>
                <c:numCache>
                  <c:formatCode>General</c:formatCode>
                  <c:ptCount val="5"/>
                  <c:pt idx="0">
                    <c:v>6.6055878256770298E-2</c:v>
                  </c:pt>
                  <c:pt idx="1">
                    <c:v>1.76013091426922E-3</c:v>
                  </c:pt>
                  <c:pt idx="2">
                    <c:v>2.6844326714669998E-2</c:v>
                  </c:pt>
                  <c:pt idx="3">
                    <c:v>1.1126726645516E-2</c:v>
                  </c:pt>
                  <c:pt idx="4">
                    <c:v>7.8760753665786998E-2</c:v>
                  </c:pt>
                </c:numCache>
              </c:numRef>
            </c:plus>
            <c:minus>
              <c:numRef>
                <c:f>Sheet1!$U$32:$U$36</c:f>
                <c:numCache>
                  <c:formatCode>General</c:formatCode>
                  <c:ptCount val="5"/>
                  <c:pt idx="0">
                    <c:v>6.6055878256770298E-2</c:v>
                  </c:pt>
                  <c:pt idx="1">
                    <c:v>1.76013091426922E-3</c:v>
                  </c:pt>
                  <c:pt idx="2">
                    <c:v>2.6844326714669998E-2</c:v>
                  </c:pt>
                  <c:pt idx="3">
                    <c:v>1.1126726645516E-2</c:v>
                  </c:pt>
                  <c:pt idx="4">
                    <c:v>7.87607536657869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O$32:$O$36</c:f>
              <c:numCache>
                <c:formatCode>General</c:formatCode>
                <c:ptCount val="5"/>
                <c:pt idx="0">
                  <c:v>0.27545288333278301</c:v>
                </c:pt>
                <c:pt idx="1">
                  <c:v>1.5167119019667301E-2</c:v>
                </c:pt>
                <c:pt idx="2">
                  <c:v>0.40381567503944998</c:v>
                </c:pt>
                <c:pt idx="3">
                  <c:v>0.104722976878509</c:v>
                </c:pt>
                <c:pt idx="4">
                  <c:v>0.45644550317097698</c:v>
                </c:pt>
              </c:numCache>
            </c:numRef>
          </c:val>
        </c:ser>
        <c:ser>
          <c:idx val="1"/>
          <c:order val="1"/>
          <c:tx>
            <c:strRef>
              <c:f>Sheet1!$P$31</c:f>
              <c:strCache>
                <c:ptCount val="1"/>
                <c:pt idx="0">
                  <c:v>Leaf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32:$V$36</c:f>
                <c:numCache>
                  <c:formatCode>General</c:formatCode>
                  <c:ptCount val="5"/>
                  <c:pt idx="0">
                    <c:v>5.7640268378771004E-3</c:v>
                  </c:pt>
                  <c:pt idx="1">
                    <c:v>2.44406671073852E-4</c:v>
                  </c:pt>
                  <c:pt idx="2">
                    <c:v>1.9671433183289601E-2</c:v>
                  </c:pt>
                  <c:pt idx="3">
                    <c:v>4.1293728785639702E-4</c:v>
                  </c:pt>
                  <c:pt idx="4">
                    <c:v>2.4659561113957499E-3</c:v>
                  </c:pt>
                </c:numCache>
              </c:numRef>
            </c:plus>
            <c:minus>
              <c:numRef>
                <c:f>Sheet1!$V$32:$V$36</c:f>
                <c:numCache>
                  <c:formatCode>General</c:formatCode>
                  <c:ptCount val="5"/>
                  <c:pt idx="0">
                    <c:v>5.7640268378771004E-3</c:v>
                  </c:pt>
                  <c:pt idx="1">
                    <c:v>2.44406671073852E-4</c:v>
                  </c:pt>
                  <c:pt idx="2">
                    <c:v>1.9671433183289601E-2</c:v>
                  </c:pt>
                  <c:pt idx="3">
                    <c:v>4.1293728785639702E-4</c:v>
                  </c:pt>
                  <c:pt idx="4">
                    <c:v>2.46595611139574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P$32:$P$36</c:f>
              <c:numCache>
                <c:formatCode>General</c:formatCode>
                <c:ptCount val="5"/>
                <c:pt idx="0">
                  <c:v>3.3357543981085799E-2</c:v>
                </c:pt>
                <c:pt idx="1">
                  <c:v>2.3007224049621001E-3</c:v>
                </c:pt>
                <c:pt idx="2">
                  <c:v>0.102158482204271</c:v>
                </c:pt>
                <c:pt idx="3">
                  <c:v>7.7978329650910403E-3</c:v>
                </c:pt>
                <c:pt idx="4">
                  <c:v>2.76990853318696E-2</c:v>
                </c:pt>
              </c:numCache>
            </c:numRef>
          </c:val>
        </c:ser>
        <c:ser>
          <c:idx val="2"/>
          <c:order val="2"/>
          <c:tx>
            <c:strRef>
              <c:f>Sheet1!$Q$31</c:f>
              <c:strCache>
                <c:ptCount val="1"/>
                <c:pt idx="0">
                  <c:v>Floret</c:v>
                </c:pt>
              </c:strCache>
            </c:strRef>
          </c:tx>
          <c:spPr>
            <a:solidFill>
              <a:srgbClr val="70AD47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32:$W$36</c:f>
                <c:numCache>
                  <c:formatCode>General</c:formatCode>
                  <c:ptCount val="5"/>
                  <c:pt idx="0">
                    <c:v>1.0621126428232401E-2</c:v>
                  </c:pt>
                  <c:pt idx="1">
                    <c:v>4.5074572308731698E-3</c:v>
                  </c:pt>
                  <c:pt idx="2">
                    <c:v>0.58429885412513105</c:v>
                  </c:pt>
                  <c:pt idx="3">
                    <c:v>3.6210744902848799E-2</c:v>
                  </c:pt>
                  <c:pt idx="4">
                    <c:v>4.3340707385268447</c:v>
                  </c:pt>
                </c:numCache>
              </c:numRef>
            </c:plus>
            <c:minus>
              <c:numRef>
                <c:f>Sheet1!$W$32:$W$36</c:f>
                <c:numCache>
                  <c:formatCode>General</c:formatCode>
                  <c:ptCount val="5"/>
                  <c:pt idx="0">
                    <c:v>1.0621126428232401E-2</c:v>
                  </c:pt>
                  <c:pt idx="1">
                    <c:v>4.5074572308731698E-3</c:v>
                  </c:pt>
                  <c:pt idx="2">
                    <c:v>0.58429885412513105</c:v>
                  </c:pt>
                  <c:pt idx="3">
                    <c:v>3.6210744902848799E-2</c:v>
                  </c:pt>
                  <c:pt idx="4">
                    <c:v>4.33407073852684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Q$32:$Q$36</c:f>
              <c:numCache>
                <c:formatCode>General</c:formatCode>
                <c:ptCount val="5"/>
                <c:pt idx="0">
                  <c:v>8.4300100974375597E-2</c:v>
                </c:pt>
                <c:pt idx="1">
                  <c:v>1.2126204902984199E-2</c:v>
                </c:pt>
                <c:pt idx="2">
                  <c:v>3.9265440823842792</c:v>
                </c:pt>
                <c:pt idx="3">
                  <c:v>0.246017273391755</c:v>
                </c:pt>
                <c:pt idx="4">
                  <c:v>17.798563134759629</c:v>
                </c:pt>
              </c:numCache>
            </c:numRef>
          </c:val>
        </c:ser>
        <c:ser>
          <c:idx val="3"/>
          <c:order val="3"/>
          <c:tx>
            <c:strRef>
              <c:f>Sheet1!$R$31</c:f>
              <c:strCache>
                <c:ptCount val="1"/>
                <c:pt idx="0">
                  <c:v>Pith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32:$X$36</c:f>
                <c:numCache>
                  <c:formatCode>General</c:formatCode>
                  <c:ptCount val="5"/>
                  <c:pt idx="0">
                    <c:v>6.8543449204981899E-3</c:v>
                  </c:pt>
                  <c:pt idx="1">
                    <c:v>4.0774524388614299E-4</c:v>
                  </c:pt>
                  <c:pt idx="2">
                    <c:v>3.59795624960265E-3</c:v>
                  </c:pt>
                  <c:pt idx="3">
                    <c:v>3.8849078661394899E-3</c:v>
                  </c:pt>
                  <c:pt idx="4">
                    <c:v>6.95197444405877E-2</c:v>
                  </c:pt>
                </c:numCache>
              </c:numRef>
            </c:plus>
            <c:minus>
              <c:numRef>
                <c:f>Sheet1!$X$32:$X$36</c:f>
                <c:numCache>
                  <c:formatCode>General</c:formatCode>
                  <c:ptCount val="5"/>
                  <c:pt idx="0">
                    <c:v>6.8543449204981899E-3</c:v>
                  </c:pt>
                  <c:pt idx="1">
                    <c:v>4.0774524388614299E-4</c:v>
                  </c:pt>
                  <c:pt idx="2">
                    <c:v>3.59795624960265E-3</c:v>
                  </c:pt>
                  <c:pt idx="3">
                    <c:v>3.8849078661394899E-3</c:v>
                  </c:pt>
                  <c:pt idx="4">
                    <c:v>6.951974444058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R$32:$R$36</c:f>
              <c:numCache>
                <c:formatCode>General</c:formatCode>
                <c:ptCount val="5"/>
                <c:pt idx="0">
                  <c:v>8.2459714321559199E-2</c:v>
                </c:pt>
                <c:pt idx="1">
                  <c:v>1.6947000726760799E-3</c:v>
                </c:pt>
                <c:pt idx="2">
                  <c:v>0.29613840228133498</c:v>
                </c:pt>
                <c:pt idx="3">
                  <c:v>6.7321061012831002E-2</c:v>
                </c:pt>
                <c:pt idx="4">
                  <c:v>1.0439849671077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922752"/>
        <c:axId val="128924288"/>
      </c:barChart>
      <c:catAx>
        <c:axId val="128922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8924288"/>
        <c:crosses val="autoZero"/>
        <c:auto val="1"/>
        <c:lblAlgn val="ctr"/>
        <c:lblOffset val="100"/>
        <c:noMultiLvlLbl val="0"/>
      </c:catAx>
      <c:valAx>
        <c:axId val="128924288"/>
        <c:scaling>
          <c:orientation val="minMax"/>
          <c:max val="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pression ratio to </a:t>
                </a:r>
                <a:r>
                  <a:rPr lang="en-US" sz="1100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F1</a:t>
                </a:r>
                <a:r>
                  <a:rPr lang="el-GR" sz="1100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1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4091710758377402E-2"/>
              <c:y val="0.2170734568153069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8922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7603771750753"/>
          <c:y val="7.2182444163391493E-2"/>
          <c:w val="0.177763659172233"/>
          <c:h val="0.1647888249720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868358276203099"/>
          <c:y val="3.9579735175590103E-2"/>
          <c:w val="0.67734987248934297"/>
          <c:h val="0.881332757628095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O$5</c:f>
              <c:strCache>
                <c:ptCount val="1"/>
                <c:pt idx="0">
                  <c:v>Spathe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U$6:$U$10</c:f>
                <c:numCache>
                  <c:formatCode>General</c:formatCode>
                  <c:ptCount val="5"/>
                  <c:pt idx="0">
                    <c:v>7.0912989014571701E-2</c:v>
                  </c:pt>
                  <c:pt idx="1">
                    <c:v>2.5939145160571702E-3</c:v>
                  </c:pt>
                  <c:pt idx="2">
                    <c:v>5.49608465586695E-2</c:v>
                  </c:pt>
                  <c:pt idx="3">
                    <c:v>1.003796967341E-2</c:v>
                  </c:pt>
                  <c:pt idx="4">
                    <c:v>4.7253042591862398E-3</c:v>
                  </c:pt>
                </c:numCache>
              </c:numRef>
            </c:plus>
            <c:minus>
              <c:numRef>
                <c:f>Sheet1!$U$6:$U$10</c:f>
                <c:numCache>
                  <c:formatCode>General</c:formatCode>
                  <c:ptCount val="5"/>
                  <c:pt idx="0">
                    <c:v>7.0912989014571701E-2</c:v>
                  </c:pt>
                  <c:pt idx="1">
                    <c:v>2.5939145160571702E-3</c:v>
                  </c:pt>
                  <c:pt idx="2">
                    <c:v>5.49608465586695E-2</c:v>
                  </c:pt>
                  <c:pt idx="3">
                    <c:v>1.003796967341E-2</c:v>
                  </c:pt>
                  <c:pt idx="4">
                    <c:v>4.72530425918623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6:$N$10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O$6:$O$10</c:f>
              <c:numCache>
                <c:formatCode>General</c:formatCode>
                <c:ptCount val="5"/>
                <c:pt idx="0">
                  <c:v>0.179780429857751</c:v>
                </c:pt>
                <c:pt idx="1">
                  <c:v>7.9404666699339592E-3</c:v>
                </c:pt>
                <c:pt idx="2">
                  <c:v>0.53983877533907298</c:v>
                </c:pt>
                <c:pt idx="3">
                  <c:v>6.2243661043517098E-2</c:v>
                </c:pt>
                <c:pt idx="4">
                  <c:v>0.12689001323915999</c:v>
                </c:pt>
              </c:numCache>
            </c:numRef>
          </c:val>
        </c:ser>
        <c:ser>
          <c:idx val="1"/>
          <c:order val="1"/>
          <c:tx>
            <c:strRef>
              <c:f>Sheet1!$P$5</c:f>
              <c:strCache>
                <c:ptCount val="1"/>
                <c:pt idx="0">
                  <c:v>Leaf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6:$V$10</c:f>
                <c:numCache>
                  <c:formatCode>General</c:formatCode>
                  <c:ptCount val="5"/>
                  <c:pt idx="0">
                    <c:v>1.02172256179376E-3</c:v>
                  </c:pt>
                  <c:pt idx="1">
                    <c:v>1.2151118878431701E-4</c:v>
                  </c:pt>
                  <c:pt idx="2">
                    <c:v>7.8253370946531307E-3</c:v>
                  </c:pt>
                  <c:pt idx="3">
                    <c:v>7.5262388758527102E-4</c:v>
                  </c:pt>
                  <c:pt idx="4">
                    <c:v>5.67698426790269E-3</c:v>
                  </c:pt>
                </c:numCache>
              </c:numRef>
            </c:plus>
            <c:minus>
              <c:numRef>
                <c:f>Sheet1!$V$6:$V$10</c:f>
                <c:numCache>
                  <c:formatCode>General</c:formatCode>
                  <c:ptCount val="5"/>
                  <c:pt idx="0">
                    <c:v>1.02172256179376E-3</c:v>
                  </c:pt>
                  <c:pt idx="1">
                    <c:v>1.2151118878431701E-4</c:v>
                  </c:pt>
                  <c:pt idx="2">
                    <c:v>7.8253370946531307E-3</c:v>
                  </c:pt>
                  <c:pt idx="3">
                    <c:v>7.5262388758527102E-4</c:v>
                  </c:pt>
                  <c:pt idx="4">
                    <c:v>5.6769842679026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6:$N$10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P$6:$P$10</c:f>
              <c:numCache>
                <c:formatCode>General</c:formatCode>
                <c:ptCount val="5"/>
                <c:pt idx="0">
                  <c:v>8.5446293462160695E-3</c:v>
                </c:pt>
                <c:pt idx="1">
                  <c:v>1.1523202408701501E-3</c:v>
                </c:pt>
                <c:pt idx="2">
                  <c:v>5.7634071905969898E-2</c:v>
                </c:pt>
                <c:pt idx="3">
                  <c:v>9.9823181828859308E-3</c:v>
                </c:pt>
                <c:pt idx="4">
                  <c:v>1.5418652619042499E-2</c:v>
                </c:pt>
              </c:numCache>
            </c:numRef>
          </c:val>
        </c:ser>
        <c:ser>
          <c:idx val="2"/>
          <c:order val="2"/>
          <c:tx>
            <c:strRef>
              <c:f>Sheet1!$Q$5</c:f>
              <c:strCache>
                <c:ptCount val="1"/>
                <c:pt idx="0">
                  <c:v>Floret</c:v>
                </c:pt>
              </c:strCache>
            </c:strRef>
          </c:tx>
          <c:spPr>
            <a:solidFill>
              <a:srgbClr val="70AD47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6:$W$10</c:f>
                <c:numCache>
                  <c:formatCode>General</c:formatCode>
                  <c:ptCount val="5"/>
                  <c:pt idx="0">
                    <c:v>9.3465832356811208E-3</c:v>
                  </c:pt>
                  <c:pt idx="1">
                    <c:v>2.1257557593829198E-3</c:v>
                  </c:pt>
                  <c:pt idx="2">
                    <c:v>0.289959444215659</c:v>
                  </c:pt>
                  <c:pt idx="3">
                    <c:v>3.1452869417602398E-2</c:v>
                  </c:pt>
                  <c:pt idx="4">
                    <c:v>2.9430824524141932</c:v>
                  </c:pt>
                </c:numCache>
              </c:numRef>
            </c:plus>
            <c:minus>
              <c:numRef>
                <c:f>Sheet1!$W$6:$W$10</c:f>
                <c:numCache>
                  <c:formatCode>General</c:formatCode>
                  <c:ptCount val="5"/>
                  <c:pt idx="0">
                    <c:v>9.3465832356811208E-3</c:v>
                  </c:pt>
                  <c:pt idx="1">
                    <c:v>2.1257557593829198E-3</c:v>
                  </c:pt>
                  <c:pt idx="2">
                    <c:v>0.289959444215659</c:v>
                  </c:pt>
                  <c:pt idx="3">
                    <c:v>3.1452869417602398E-2</c:v>
                  </c:pt>
                  <c:pt idx="4">
                    <c:v>2.94308245241419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6:$N$10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Q$6:$Q$10</c:f>
              <c:numCache>
                <c:formatCode>General</c:formatCode>
                <c:ptCount val="5"/>
                <c:pt idx="0">
                  <c:v>0.105072877481679</c:v>
                </c:pt>
                <c:pt idx="1">
                  <c:v>1.0257577318493701E-2</c:v>
                </c:pt>
                <c:pt idx="2">
                  <c:v>3.9673326447126702</c:v>
                </c:pt>
                <c:pt idx="3">
                  <c:v>0.19694095534783901</c:v>
                </c:pt>
                <c:pt idx="4">
                  <c:v>11.326566965069439</c:v>
                </c:pt>
              </c:numCache>
            </c:numRef>
          </c:val>
        </c:ser>
        <c:ser>
          <c:idx val="3"/>
          <c:order val="3"/>
          <c:tx>
            <c:strRef>
              <c:f>Sheet1!$R$5</c:f>
              <c:strCache>
                <c:ptCount val="1"/>
                <c:pt idx="0">
                  <c:v>Pith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6:$X$10</c:f>
                <c:numCache>
                  <c:formatCode>General</c:formatCode>
                  <c:ptCount val="5"/>
                  <c:pt idx="0">
                    <c:v>1.6014925364591402E-2</c:v>
                  </c:pt>
                  <c:pt idx="1">
                    <c:v>2.44061490543245E-4</c:v>
                  </c:pt>
                  <c:pt idx="2">
                    <c:v>0.144083263300367</c:v>
                  </c:pt>
                  <c:pt idx="3">
                    <c:v>1.6682031135722E-2</c:v>
                  </c:pt>
                  <c:pt idx="4">
                    <c:v>0.20773307569848001</c:v>
                  </c:pt>
                </c:numCache>
              </c:numRef>
            </c:plus>
            <c:minus>
              <c:numRef>
                <c:f>Sheet1!$X$6:$X$10</c:f>
                <c:numCache>
                  <c:formatCode>General</c:formatCode>
                  <c:ptCount val="5"/>
                  <c:pt idx="0">
                    <c:v>1.6014925364591402E-2</c:v>
                  </c:pt>
                  <c:pt idx="1">
                    <c:v>2.44061490543245E-4</c:v>
                  </c:pt>
                  <c:pt idx="2">
                    <c:v>0.144083263300367</c:v>
                  </c:pt>
                  <c:pt idx="3">
                    <c:v>1.6682031135722E-2</c:v>
                  </c:pt>
                  <c:pt idx="4">
                    <c:v>0.20773307569848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6:$N$10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1!$R$6:$R$10</c:f>
              <c:numCache>
                <c:formatCode>General</c:formatCode>
                <c:ptCount val="5"/>
                <c:pt idx="0">
                  <c:v>5.4071610180930797E-2</c:v>
                </c:pt>
                <c:pt idx="1">
                  <c:v>1.0585327328153399E-3</c:v>
                </c:pt>
                <c:pt idx="2">
                  <c:v>0.92064091689605698</c:v>
                </c:pt>
                <c:pt idx="3">
                  <c:v>8.2909208496746406E-2</c:v>
                </c:pt>
                <c:pt idx="4">
                  <c:v>1.32794970218080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181824"/>
        <c:axId val="137183616"/>
      </c:barChart>
      <c:catAx>
        <c:axId val="137181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7183616"/>
        <c:crosses val="autoZero"/>
        <c:auto val="1"/>
        <c:lblAlgn val="ctr"/>
        <c:lblOffset val="100"/>
        <c:noMultiLvlLbl val="0"/>
      </c:catAx>
      <c:valAx>
        <c:axId val="137183616"/>
        <c:scaling>
          <c:orientation val="minMax"/>
          <c:max val="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pression ratio to </a:t>
                </a:r>
                <a:r>
                  <a:rPr lang="en-US" sz="1100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F1</a:t>
                </a:r>
                <a:r>
                  <a:rPr lang="el-GR" sz="1100" b="1" i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1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6541250244953897E-2"/>
              <c:y val="0.2361198940158389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7181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495243945570599"/>
          <c:y val="4.1111216965996102E-2"/>
          <c:w val="0.16061688276619701"/>
          <c:h val="0.214371635696421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76363" cy="513508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5" y="2"/>
            <a:ext cx="3076363" cy="513508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>
              <a:defRPr sz="1200"/>
            </a:lvl1pPr>
          </a:lstStyle>
          <a:p>
            <a:fld id="{9D67A089-3EC3-4620-BEEE-B1748E8A2621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925407"/>
            <a:ext cx="5679440" cy="4029879"/>
          </a:xfrm>
          <a:prstGeom prst="rect">
            <a:avLst/>
          </a:prstGeom>
        </p:spPr>
        <p:txBody>
          <a:bodyPr vert="horz" lIns="94768" tIns="47384" rIns="94768" bIns="4738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721108"/>
            <a:ext cx="3076363" cy="513507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5" y="9721108"/>
            <a:ext cx="3076363" cy="513507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>
              <a:defRPr sz="1200"/>
            </a:lvl1pPr>
          </a:lstStyle>
          <a:p>
            <a:fld id="{8B992F4F-6D07-4AA1-BEBD-0C3C3AE2D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905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10" indent="0" algn="ctr">
              <a:buNone/>
              <a:defRPr sz="1500"/>
            </a:lvl2pPr>
            <a:lvl3pPr marL="685822" indent="0" algn="ctr">
              <a:buNone/>
              <a:defRPr sz="1350"/>
            </a:lvl3pPr>
            <a:lvl4pPr marL="1028732" indent="0" algn="ctr">
              <a:buNone/>
              <a:defRPr sz="1200"/>
            </a:lvl4pPr>
            <a:lvl5pPr marL="1371643" indent="0" algn="ctr">
              <a:buNone/>
              <a:defRPr sz="1200"/>
            </a:lvl5pPr>
            <a:lvl6pPr marL="1714553" indent="0" algn="ctr">
              <a:buNone/>
              <a:defRPr sz="1200"/>
            </a:lvl6pPr>
            <a:lvl7pPr marL="2057465" indent="0" algn="ctr">
              <a:buNone/>
              <a:defRPr sz="1200"/>
            </a:lvl7pPr>
            <a:lvl8pPr marL="2400375" indent="0" algn="ctr">
              <a:buNone/>
              <a:defRPr sz="1200"/>
            </a:lvl8pPr>
            <a:lvl9pPr marL="2743285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92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98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0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56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5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1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2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6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83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5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447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34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96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583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10" indent="0">
              <a:buNone/>
              <a:defRPr sz="2100"/>
            </a:lvl2pPr>
            <a:lvl3pPr marL="685822" indent="0">
              <a:buNone/>
              <a:defRPr sz="1800"/>
            </a:lvl3pPr>
            <a:lvl4pPr marL="1028732" indent="0">
              <a:buNone/>
              <a:defRPr sz="1500"/>
            </a:lvl4pPr>
            <a:lvl5pPr marL="1371643" indent="0">
              <a:buNone/>
              <a:defRPr sz="1500"/>
            </a:lvl5pPr>
            <a:lvl6pPr marL="1714553" indent="0">
              <a:buNone/>
              <a:defRPr sz="1500"/>
            </a:lvl6pPr>
            <a:lvl7pPr marL="2057465" indent="0">
              <a:buNone/>
              <a:defRPr sz="1500"/>
            </a:lvl7pPr>
            <a:lvl8pPr marL="2400375" indent="0">
              <a:buNone/>
              <a:defRPr sz="1500"/>
            </a:lvl8pPr>
            <a:lvl9pPr marL="2743285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257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88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2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6" indent="-171456" algn="l" defTabSz="68582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6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77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8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9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0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91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3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4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1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2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3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4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5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6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7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8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063687" y="209623"/>
            <a:ext cx="4772133" cy="7153369"/>
            <a:chOff x="923010" y="295592"/>
            <a:chExt cx="4772133" cy="7153369"/>
          </a:xfrm>
        </p:grpSpPr>
        <p:sp>
          <p:nvSpPr>
            <p:cNvPr id="30" name="テキスト ボックス 29"/>
            <p:cNvSpPr txBox="1"/>
            <p:nvPr/>
          </p:nvSpPr>
          <p:spPr>
            <a:xfrm>
              <a:off x="923010" y="295592"/>
              <a:ext cx="4399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923010" y="4077410"/>
              <a:ext cx="4399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32906291"/>
                </p:ext>
              </p:extLst>
            </p:nvPr>
          </p:nvGraphicFramePr>
          <p:xfrm>
            <a:off x="1386944" y="4414188"/>
            <a:ext cx="4308199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3" name="テキスト ボックス 25"/>
            <p:cNvSpPr txBox="1"/>
            <p:nvPr/>
          </p:nvSpPr>
          <p:spPr>
            <a:xfrm>
              <a:off x="2197462" y="7195045"/>
              <a:ext cx="2939224" cy="2539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PK      SrPEPtase  SrPEPC  SrPEPCK     SrAOX</a:t>
              </a:r>
              <a:endParaRPr kumimoji="1" lang="ja-JP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5735530"/>
                </p:ext>
              </p:extLst>
            </p:nvPr>
          </p:nvGraphicFramePr>
          <p:xfrm>
            <a:off x="1380210" y="818812"/>
            <a:ext cx="4297680" cy="30335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8" name="テキスト ボックス 25"/>
            <p:cNvSpPr txBox="1"/>
            <p:nvPr/>
          </p:nvSpPr>
          <p:spPr>
            <a:xfrm>
              <a:off x="2140546" y="3632902"/>
              <a:ext cx="2880028" cy="2539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PK      SrPEPtase  SrPEPC  SrPEPCK     SrAOX</a:t>
              </a:r>
              <a:endParaRPr kumimoji="1" lang="ja-JP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"/>
            <p:cNvSpPr txBox="1"/>
            <p:nvPr/>
          </p:nvSpPr>
          <p:spPr>
            <a:xfrm rot="16200000">
              <a:off x="681966" y="2262041"/>
              <a:ext cx="190260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ratio to </a:t>
              </a:r>
              <a:r>
                <a:rPr kumimoji="1" lang="en-US" altLang="ja-JP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F1</a:t>
              </a:r>
              <a:r>
                <a:rPr kumimoji="1" lang="en-US" altLang="ja-JP" sz="1200" i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kumimoji="1" lang="ja-JP" altLang="en-US" sz="1200" i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"/>
            <p:cNvSpPr txBox="1"/>
            <p:nvPr/>
          </p:nvSpPr>
          <p:spPr>
            <a:xfrm rot="16200000">
              <a:off x="699219" y="5764361"/>
              <a:ext cx="190260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ratio to </a:t>
              </a:r>
              <a:r>
                <a:rPr kumimoji="1" lang="en-US" altLang="ja-JP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F1</a:t>
              </a:r>
              <a:r>
                <a:rPr kumimoji="1" lang="en-US" altLang="ja-JP" sz="1200" i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kumimoji="1" lang="ja-JP" altLang="en-US" sz="1200" i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sp>
        <p:nvSpPr>
          <p:cNvPr id="3" name="テキスト ボックス 2"/>
          <p:cNvSpPr txBox="1"/>
          <p:nvPr/>
        </p:nvSpPr>
        <p:spPr>
          <a:xfrm>
            <a:off x="954695" y="7634650"/>
            <a:ext cx="553356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Figure 1. </a:t>
            </a:r>
            <a:r>
              <a:rPr lang="en-US" altLang="ja-JP" sz="1050" dirty="0">
                <a:latin typeface="Arial"/>
                <a:cs typeface="Arial"/>
              </a:rPr>
              <a:t>qRT-PCR analyses for </a:t>
            </a:r>
            <a:r>
              <a:rPr lang="en-US" altLang="ja-JP" sz="1050" i="1" dirty="0" smtClean="0">
                <a:latin typeface="Arial"/>
                <a:cs typeface="Arial"/>
              </a:rPr>
              <a:t>SrPK</a:t>
            </a:r>
            <a:r>
              <a:rPr lang="en-US" altLang="ja-JP" sz="1050" dirty="0">
                <a:latin typeface="Arial"/>
                <a:cs typeface="Arial"/>
              </a:rPr>
              <a:t>, </a:t>
            </a:r>
            <a:r>
              <a:rPr lang="en-US" altLang="ja-JP" sz="1050" i="1" dirty="0">
                <a:latin typeface="Arial"/>
                <a:cs typeface="Arial"/>
              </a:rPr>
              <a:t>SrPEPtase</a:t>
            </a:r>
            <a:r>
              <a:rPr lang="en-US" altLang="ja-JP" sz="1050" i="1" dirty="0" smtClean="0">
                <a:latin typeface="Arial"/>
                <a:cs typeface="Arial"/>
              </a:rPr>
              <a:t>, </a:t>
            </a:r>
            <a:r>
              <a:rPr lang="en-US" altLang="ja-JP" sz="1050" i="1" dirty="0">
                <a:latin typeface="Arial"/>
                <a:cs typeface="Arial"/>
              </a:rPr>
              <a:t>SrPEPC</a:t>
            </a:r>
            <a:r>
              <a:rPr lang="en-US" altLang="ja-JP" sz="1050" dirty="0">
                <a:latin typeface="Arial"/>
                <a:cs typeface="Arial"/>
              </a:rPr>
              <a:t>, </a:t>
            </a:r>
            <a:r>
              <a:rPr lang="en-US" altLang="ja-JP" sz="1050" i="1" dirty="0">
                <a:latin typeface="Arial"/>
                <a:cs typeface="Arial"/>
              </a:rPr>
              <a:t>SrPEPCK</a:t>
            </a:r>
            <a:r>
              <a:rPr lang="en-US" altLang="ja-JP" sz="1050" dirty="0">
                <a:latin typeface="Arial"/>
                <a:cs typeface="Arial"/>
              </a:rPr>
              <a:t>, and </a:t>
            </a:r>
            <a:r>
              <a:rPr lang="en-US" altLang="ja-JP" sz="1050" i="1" dirty="0">
                <a:latin typeface="Arial"/>
                <a:cs typeface="Arial"/>
              </a:rPr>
              <a:t>SrAOX</a:t>
            </a:r>
            <a:r>
              <a:rPr lang="en-US" altLang="ja-JP" sz="1050" dirty="0" smtClean="0">
                <a:latin typeface="Arial"/>
                <a:cs typeface="Arial"/>
              </a:rPr>
              <a:t> </a:t>
            </a:r>
            <a:r>
              <a:rPr lang="en-US" altLang="ja-JP" sz="1050" dirty="0">
                <a:latin typeface="Arial"/>
                <a:cs typeface="Arial"/>
              </a:rPr>
              <a:t>transcripts in various tissues of thermogenic stage of </a:t>
            </a:r>
            <a:r>
              <a:rPr lang="en-US" altLang="ja-JP" sz="1050" i="1" dirty="0">
                <a:latin typeface="Arial"/>
                <a:cs typeface="Arial"/>
              </a:rPr>
              <a:t>S. renifolius</a:t>
            </a:r>
            <a:r>
              <a:rPr lang="en-US" altLang="ja-JP" sz="1050" dirty="0">
                <a:latin typeface="Arial"/>
                <a:cs typeface="Arial"/>
              </a:rPr>
              <a:t>. Samples for the spathe, leaf, floret, and pith were collected from two different plants (a &amp; b) at Omori, Akita prefecture, Japan on April 1, 2014</a:t>
            </a:r>
            <a:r>
              <a:rPr lang="en-US" altLang="ja-JP" sz="1050" dirty="0" smtClean="0">
                <a:latin typeface="Arial"/>
                <a:cs typeface="Arial"/>
              </a:rPr>
              <a:t>.</a:t>
            </a:r>
            <a:r>
              <a:rPr lang="ja-JP" altLang="en-US" sz="1050" dirty="0">
                <a:latin typeface="Arial"/>
                <a:cs typeface="Arial"/>
              </a:rPr>
              <a:t> </a:t>
            </a:r>
            <a:r>
              <a:rPr lang="en-US" altLang="ja-JP" sz="1050" dirty="0" smtClean="0">
                <a:latin typeface="Arial"/>
                <a:cs typeface="Arial"/>
              </a:rPr>
              <a:t>Temperatures of ambient air (</a:t>
            </a:r>
            <a:r>
              <a:rPr lang="en-US" altLang="ja-JP" sz="1050" i="1" dirty="0" smtClean="0">
                <a:latin typeface="Arial"/>
                <a:cs typeface="Arial"/>
              </a:rPr>
              <a:t>Ta</a:t>
            </a:r>
            <a:r>
              <a:rPr lang="en-US" altLang="ja-JP" sz="1050" dirty="0" smtClean="0">
                <a:latin typeface="Arial"/>
                <a:cs typeface="Arial"/>
              </a:rPr>
              <a:t>) and the spadix (</a:t>
            </a:r>
            <a:r>
              <a:rPr lang="en-US" altLang="ja-JP" sz="1050" i="1" dirty="0" smtClean="0">
                <a:latin typeface="Arial"/>
                <a:cs typeface="Arial"/>
              </a:rPr>
              <a:t>Ts</a:t>
            </a:r>
            <a:r>
              <a:rPr lang="en-US" altLang="ja-JP" sz="1050" dirty="0" smtClean="0">
                <a:latin typeface="Arial"/>
                <a:cs typeface="Arial"/>
              </a:rPr>
              <a:t>) are also shown. </a:t>
            </a:r>
            <a:r>
              <a:rPr lang="en-US" altLang="ja-JP" sz="1050" i="1" dirty="0">
                <a:latin typeface="Arial"/>
                <a:cs typeface="Arial"/>
              </a:rPr>
              <a:t>EF1α</a:t>
            </a:r>
            <a:r>
              <a:rPr lang="en-US" altLang="ja-JP" sz="1050" dirty="0">
                <a:latin typeface="Arial"/>
                <a:cs typeface="Arial"/>
              </a:rPr>
              <a:t> transcripts were used as a normalization control. Experiments were performed in triplicate for each sample. Data are expressed as the mean ± standard deviation. Values with different letters in the </a:t>
            </a:r>
            <a:r>
              <a:rPr lang="en-US" altLang="ja-JP" sz="1050" dirty="0" smtClean="0">
                <a:latin typeface="Arial"/>
                <a:cs typeface="Arial"/>
              </a:rPr>
              <a:t>graph indicate </a:t>
            </a:r>
            <a:r>
              <a:rPr lang="en-US" altLang="ja-JP" sz="1050" dirty="0">
                <a:latin typeface="Arial"/>
                <a:cs typeface="Arial"/>
              </a:rPr>
              <a:t>that they are statistically significantly different (</a:t>
            </a:r>
            <a:r>
              <a:rPr lang="en-US" altLang="ja-JP" sz="1050" i="1" dirty="0">
                <a:latin typeface="Arial"/>
                <a:cs typeface="Arial"/>
              </a:rPr>
              <a:t>n</a:t>
            </a:r>
            <a:r>
              <a:rPr lang="en-US" altLang="ja-JP" sz="1050" dirty="0">
                <a:latin typeface="Arial"/>
                <a:cs typeface="Arial"/>
              </a:rPr>
              <a:t> = 3; </a:t>
            </a:r>
            <a:r>
              <a:rPr lang="en-US" altLang="ja-JP" sz="1050" i="1" dirty="0" smtClean="0">
                <a:latin typeface="Arial"/>
                <a:cs typeface="Arial"/>
              </a:rPr>
              <a:t>P</a:t>
            </a:r>
            <a:r>
              <a:rPr lang="en-US" altLang="ja-JP" sz="1050" dirty="0" smtClean="0">
                <a:latin typeface="Arial"/>
                <a:cs typeface="Arial"/>
              </a:rPr>
              <a:t>&lt;0.05).</a:t>
            </a:r>
            <a:endParaRPr lang="ja-JP" altLang="ja-JP" sz="1050" dirty="0">
              <a:latin typeface="Arial"/>
              <a:cs typeface="Arial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069428" y="1060984"/>
            <a:ext cx="963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: 10.5 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r>
              <a:rPr kumimoji="1"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: 25.0 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069428" y="4780238"/>
            <a:ext cx="963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: 11.4 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r>
              <a:rPr kumimoji="1" lang="en-US" altLang="ja-JP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s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: 22.7 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83"/>
          <p:cNvSpPr txBox="1"/>
          <p:nvPr/>
        </p:nvSpPr>
        <p:spPr>
          <a:xfrm>
            <a:off x="2250079" y="33487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5"/>
          <p:cNvSpPr txBox="1"/>
          <p:nvPr/>
        </p:nvSpPr>
        <p:spPr>
          <a:xfrm>
            <a:off x="2366084" y="33487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86"/>
          <p:cNvSpPr txBox="1"/>
          <p:nvPr/>
        </p:nvSpPr>
        <p:spPr>
          <a:xfrm>
            <a:off x="2477271" y="33487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86"/>
          <p:cNvSpPr txBox="1"/>
          <p:nvPr/>
        </p:nvSpPr>
        <p:spPr>
          <a:xfrm>
            <a:off x="2598095" y="33487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83"/>
          <p:cNvSpPr txBox="1"/>
          <p:nvPr/>
        </p:nvSpPr>
        <p:spPr>
          <a:xfrm>
            <a:off x="2840661" y="336803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85"/>
          <p:cNvSpPr txBox="1"/>
          <p:nvPr/>
        </p:nvSpPr>
        <p:spPr>
          <a:xfrm>
            <a:off x="2944870" y="336803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86"/>
          <p:cNvSpPr txBox="1"/>
          <p:nvPr/>
        </p:nvSpPr>
        <p:spPr>
          <a:xfrm>
            <a:off x="3049079" y="336803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86"/>
          <p:cNvSpPr txBox="1"/>
          <p:nvPr/>
        </p:nvSpPr>
        <p:spPr>
          <a:xfrm>
            <a:off x="3174432" y="336803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83"/>
          <p:cNvSpPr txBox="1"/>
          <p:nvPr/>
        </p:nvSpPr>
        <p:spPr>
          <a:xfrm>
            <a:off x="3428561" y="334802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85"/>
          <p:cNvSpPr txBox="1"/>
          <p:nvPr/>
        </p:nvSpPr>
        <p:spPr>
          <a:xfrm>
            <a:off x="3531883" y="336727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86"/>
          <p:cNvSpPr txBox="1"/>
          <p:nvPr/>
        </p:nvSpPr>
        <p:spPr>
          <a:xfrm>
            <a:off x="3643111" y="317389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86"/>
          <p:cNvSpPr txBox="1"/>
          <p:nvPr/>
        </p:nvSpPr>
        <p:spPr>
          <a:xfrm>
            <a:off x="3752767" y="331658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83"/>
          <p:cNvSpPr txBox="1"/>
          <p:nvPr/>
        </p:nvSpPr>
        <p:spPr>
          <a:xfrm>
            <a:off x="4007442" y="335876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85"/>
          <p:cNvSpPr txBox="1"/>
          <p:nvPr/>
        </p:nvSpPr>
        <p:spPr>
          <a:xfrm>
            <a:off x="4123447" y="336081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4" name="TextBox 186"/>
          <p:cNvSpPr txBox="1"/>
          <p:nvPr/>
        </p:nvSpPr>
        <p:spPr>
          <a:xfrm>
            <a:off x="4239452" y="336081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86"/>
          <p:cNvSpPr txBox="1"/>
          <p:nvPr/>
        </p:nvSpPr>
        <p:spPr>
          <a:xfrm>
            <a:off x="4355458" y="336779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83"/>
          <p:cNvSpPr txBox="1"/>
          <p:nvPr/>
        </p:nvSpPr>
        <p:spPr>
          <a:xfrm>
            <a:off x="4595614" y="336583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85"/>
          <p:cNvSpPr txBox="1"/>
          <p:nvPr/>
        </p:nvSpPr>
        <p:spPr>
          <a:xfrm>
            <a:off x="4695406" y="336974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86"/>
          <p:cNvSpPr txBox="1"/>
          <p:nvPr/>
        </p:nvSpPr>
        <p:spPr>
          <a:xfrm>
            <a:off x="4805402" y="272025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86"/>
          <p:cNvSpPr txBox="1"/>
          <p:nvPr/>
        </p:nvSpPr>
        <p:spPr>
          <a:xfrm>
            <a:off x="4919820" y="330105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83"/>
          <p:cNvSpPr txBox="1"/>
          <p:nvPr/>
        </p:nvSpPr>
        <p:spPr>
          <a:xfrm>
            <a:off x="2265054" y="691032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85"/>
          <p:cNvSpPr txBox="1"/>
          <p:nvPr/>
        </p:nvSpPr>
        <p:spPr>
          <a:xfrm>
            <a:off x="2381059" y="691032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2" name="TextBox 186"/>
          <p:cNvSpPr txBox="1"/>
          <p:nvPr/>
        </p:nvSpPr>
        <p:spPr>
          <a:xfrm>
            <a:off x="2497064" y="691032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86"/>
          <p:cNvSpPr txBox="1"/>
          <p:nvPr/>
        </p:nvSpPr>
        <p:spPr>
          <a:xfrm>
            <a:off x="2613070" y="691032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83"/>
          <p:cNvSpPr txBox="1"/>
          <p:nvPr/>
        </p:nvSpPr>
        <p:spPr>
          <a:xfrm>
            <a:off x="2855636" y="692960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85"/>
          <p:cNvSpPr txBox="1"/>
          <p:nvPr/>
        </p:nvSpPr>
        <p:spPr>
          <a:xfrm>
            <a:off x="2959845" y="692960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6" name="TextBox 186"/>
          <p:cNvSpPr txBox="1"/>
          <p:nvPr/>
        </p:nvSpPr>
        <p:spPr>
          <a:xfrm>
            <a:off x="3064054" y="692960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86"/>
          <p:cNvSpPr txBox="1"/>
          <p:nvPr/>
        </p:nvSpPr>
        <p:spPr>
          <a:xfrm>
            <a:off x="3181868" y="692960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83"/>
          <p:cNvSpPr txBox="1"/>
          <p:nvPr/>
        </p:nvSpPr>
        <p:spPr>
          <a:xfrm>
            <a:off x="3443536" y="690960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85"/>
          <p:cNvSpPr txBox="1"/>
          <p:nvPr/>
        </p:nvSpPr>
        <p:spPr>
          <a:xfrm>
            <a:off x="3562716" y="692356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86"/>
          <p:cNvSpPr txBox="1"/>
          <p:nvPr/>
        </p:nvSpPr>
        <p:spPr>
          <a:xfrm>
            <a:off x="3660807" y="673546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86"/>
          <p:cNvSpPr txBox="1"/>
          <p:nvPr/>
        </p:nvSpPr>
        <p:spPr>
          <a:xfrm>
            <a:off x="3767742" y="690785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83"/>
          <p:cNvSpPr txBox="1"/>
          <p:nvPr/>
        </p:nvSpPr>
        <p:spPr>
          <a:xfrm>
            <a:off x="4022417" y="692034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85"/>
          <p:cNvSpPr txBox="1"/>
          <p:nvPr/>
        </p:nvSpPr>
        <p:spPr>
          <a:xfrm>
            <a:off x="4138422" y="692239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" name="TextBox 186"/>
          <p:cNvSpPr txBox="1"/>
          <p:nvPr/>
        </p:nvSpPr>
        <p:spPr>
          <a:xfrm>
            <a:off x="4254427" y="692239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86"/>
          <p:cNvSpPr txBox="1"/>
          <p:nvPr/>
        </p:nvSpPr>
        <p:spPr>
          <a:xfrm>
            <a:off x="4370433" y="692937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183"/>
          <p:cNvSpPr txBox="1"/>
          <p:nvPr/>
        </p:nvSpPr>
        <p:spPr>
          <a:xfrm>
            <a:off x="4625342" y="689328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185"/>
          <p:cNvSpPr txBox="1"/>
          <p:nvPr/>
        </p:nvSpPr>
        <p:spPr>
          <a:xfrm>
            <a:off x="4724326" y="69199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86"/>
          <p:cNvSpPr txBox="1"/>
          <p:nvPr/>
        </p:nvSpPr>
        <p:spPr>
          <a:xfrm>
            <a:off x="4841209" y="594959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186"/>
          <p:cNvSpPr txBox="1"/>
          <p:nvPr/>
        </p:nvSpPr>
        <p:spPr>
          <a:xfrm>
            <a:off x="4947932" y="686807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9644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3</TotalTime>
  <Words>218</Words>
  <Application>Microsoft Office PowerPoint</Application>
  <PresentationFormat>画面に合わせる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viewer</dc:creator>
  <cp:lastModifiedBy>Kikukatsu Ito</cp:lastModifiedBy>
  <cp:revision>375</cp:revision>
  <cp:lastPrinted>2016-09-21T04:13:31Z</cp:lastPrinted>
  <dcterms:created xsi:type="dcterms:W3CDTF">2016-01-08T01:07:56Z</dcterms:created>
  <dcterms:modified xsi:type="dcterms:W3CDTF">2016-11-01T02:42:29Z</dcterms:modified>
</cp:coreProperties>
</file>